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184775" cy="4392613"/>
  <p:notesSz cx="6781800" cy="99187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B0DE9D-71F7-41BB-BEC2-FA71FE0C3E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46670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58840" y="2539800"/>
            <a:ext cx="46670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60BA33-E3B5-4171-B5AB-71E26B388D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65032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58840" y="253980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650320" y="253980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1E242-C4CA-43C3-9189-EB5CB5A668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837080" y="102564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415320" y="102564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58840" y="253980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837080" y="253980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415320" y="2539800"/>
            <a:ext cx="15026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E93C4-C3FE-4B52-A4E2-533AC5EA2B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58840" y="1025640"/>
            <a:ext cx="4667040" cy="2898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02B68B-AF67-4852-A426-576C950428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466704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CA591-6A52-4383-846D-070EDA5044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227736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650320" y="1025640"/>
            <a:ext cx="227736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DB3E2-80DF-4B07-BC67-62A78725F3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55E5C7-C3BC-49F6-8C97-F1D18CE3C8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58840" y="175680"/>
            <a:ext cx="4667040" cy="3393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8EE93-01D4-41B9-A115-422B504C86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650320" y="1025640"/>
            <a:ext cx="227736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58840" y="253980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7828B1-4B41-4F56-A1C6-608C119AAA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227736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65032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650320" y="253980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491C8-53C8-4137-9D77-810E670D95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5884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650320" y="1025640"/>
            <a:ext cx="227736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58840" y="2539800"/>
            <a:ext cx="4667040" cy="138240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B787E-2617-4B71-A668-F9A3A302C9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58840" y="175680"/>
            <a:ext cx="4667040" cy="73188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ctr">
            <a:noAutofit/>
          </a:bodyPr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2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58840" y="1025640"/>
            <a:ext cx="4667040" cy="289872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rmAutofit/>
          </a:bodyPr>
          <a:p>
            <a:pPr marL="195120" indent="-19512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422280" indent="-1620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649440" indent="-12888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3" marL="909720" indent="-1303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4" marL="1170000" indent="-1303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5" marL="1170000" indent="-1303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6" marL="1170000" indent="-13032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58840" y="4000320"/>
            <a:ext cx="1211040" cy="30636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Autofit/>
          </a:bodyPr>
          <a:lstStyle>
            <a:lvl1pPr indent="0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771560" y="4000320"/>
            <a:ext cx="1641600" cy="30636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Autofit/>
          </a:bodyPr>
          <a:lstStyle>
            <a:lvl1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714840" y="4000320"/>
            <a:ext cx="1211040" cy="306360"/>
          </a:xfrm>
          <a:prstGeom prst="rect">
            <a:avLst/>
          </a:prstGeom>
          <a:noFill/>
          <a:ln w="0">
            <a:noFill/>
          </a:ln>
        </p:spPr>
        <p:txBody>
          <a:bodyPr lIns="51840" rIns="51840" tIns="25920" bIns="25920" anchor="t">
            <a:noAutofit/>
          </a:bodyPr>
          <a:lstStyle>
            <a:lvl1pPr indent="0" algn="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  <a:defRPr b="0" lang="en-GB" sz="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520560"/>
                <a:tab algn="l" pos="1041480"/>
                <a:tab algn="l" pos="1562040"/>
                <a:tab algn="l" pos="2082960"/>
                <a:tab algn="l" pos="2603520"/>
                <a:tab algn="l" pos="3124080"/>
                <a:tab algn="l" pos="3645000"/>
                <a:tab algn="l" pos="4165560"/>
                <a:tab algn="l" pos="4686480"/>
                <a:tab algn="l" pos="5207040"/>
                <a:tab algn="l" pos="5727600"/>
                <a:tab algn="l" pos="6248520"/>
                <a:tab algn="l" pos="6769080"/>
                <a:tab algn="l" pos="7289640"/>
                <a:tab algn="l" pos="7810560"/>
                <a:tab algn="l" pos="8331120"/>
                <a:tab algn="l" pos="8852040"/>
                <a:tab algn="l" pos="9372600"/>
                <a:tab algn="l" pos="9893160"/>
                <a:tab algn="l" pos="10414080"/>
              </a:tabLst>
            </a:pPr>
            <a:fld id="{E3D3691F-E70C-472A-9DD7-CAF4A664B93E}" type="slidenum">
              <a:rPr b="0" lang="en-GB" sz="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2520" y="4319640"/>
            <a:ext cx="249120" cy="1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61720" y="4135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 flipV="1">
            <a:off x="1616040" y="2452680"/>
            <a:ext cx="793800" cy="565200"/>
          </a:xfrm>
          <a:prstGeom prst="line">
            <a:avLst/>
          </a:prstGeom>
          <a:ln cap="sq" w="158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rot="19304400">
            <a:off x="1206000" y="312876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V="1">
            <a:off x="938160" y="2874600"/>
            <a:ext cx="295200" cy="452520"/>
          </a:xfrm>
          <a:prstGeom prst="line">
            <a:avLst/>
          </a:prstGeom>
          <a:ln cap="sq" w="15840">
            <a:solidFill>
              <a:srgbClr val="99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17773200">
            <a:off x="714240" y="3444480"/>
            <a:ext cx="32976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LR1lik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960480" y="2937960"/>
            <a:ext cx="65160" cy="133560"/>
          </a:xfrm>
          <a:prstGeom prst="line">
            <a:avLst/>
          </a:prstGeom>
          <a:ln cap="sq" w="15840">
            <a:solidFill>
              <a:srgbClr val="ff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7928000">
            <a:off x="538560" y="3285720"/>
            <a:ext cx="541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1lik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719280" y="3223800"/>
            <a:ext cx="48960" cy="12852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7613000">
            <a:off x="448920" y="350352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558720" y="3259080"/>
            <a:ext cx="115920" cy="2304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8301200">
            <a:off x="203400" y="3647520"/>
            <a:ext cx="438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rmadillo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441360" y="3301920"/>
            <a:ext cx="114120" cy="10008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9208400">
            <a:off x="159120" y="34779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80880" y="3273480"/>
            <a:ext cx="174600" cy="284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9000" y="323208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555480" y="3258720"/>
            <a:ext cx="119160" cy="428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674640" y="3223800"/>
            <a:ext cx="93600" cy="3492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768240" y="3112560"/>
            <a:ext cx="39960" cy="1112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463680" y="3126960"/>
            <a:ext cx="123840" cy="1764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77480" y="311004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69800" y="3087720"/>
            <a:ext cx="117720" cy="396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96120" y="30481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587520" y="3112920"/>
            <a:ext cx="220680" cy="144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V="1">
            <a:off x="808200" y="2912760"/>
            <a:ext cx="125280" cy="199800"/>
          </a:xfrm>
          <a:prstGeom prst="line">
            <a:avLst/>
          </a:prstGeom>
          <a:ln cap="sq" w="1584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426960" y="2954160"/>
            <a:ext cx="14400" cy="129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82440" y="297036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31640" y="2954160"/>
            <a:ext cx="9720" cy="180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8960" y="291456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V="1">
            <a:off x="441360" y="2873520"/>
            <a:ext cx="147600" cy="8064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3840" bIns="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333360" y="2806560"/>
            <a:ext cx="123840" cy="525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760" bIns="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1760" y="282420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49200" y="2730600"/>
            <a:ext cx="108000" cy="759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2680" y="26877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57200" y="2806560"/>
            <a:ext cx="131760" cy="669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588960" y="2862000"/>
            <a:ext cx="123840" cy="111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60440" y="2644920"/>
            <a:ext cx="109440" cy="4104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6760" y="26035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84200" y="2576520"/>
            <a:ext cx="85680" cy="10944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91880" y="252720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69880" y="2685960"/>
            <a:ext cx="142920" cy="17640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12800" y="2862360"/>
            <a:ext cx="220680" cy="50760"/>
          </a:xfrm>
          <a:prstGeom prst="line">
            <a:avLst/>
          </a:prstGeom>
          <a:ln cap="sq" w="15840">
            <a:solidFill>
              <a:srgbClr val="9966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933480" y="2913120"/>
            <a:ext cx="92160" cy="252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flipV="1">
            <a:off x="1025640" y="2874960"/>
            <a:ext cx="207720" cy="633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1233360" y="2635200"/>
            <a:ext cx="144720" cy="23976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579600" y="2459160"/>
            <a:ext cx="163440" cy="1116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7480" y="2421000"/>
            <a:ext cx="48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L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79600" y="2374920"/>
            <a:ext cx="163440" cy="9540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87480" y="2332080"/>
            <a:ext cx="48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1L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743040" y="2470320"/>
            <a:ext cx="422280" cy="125280"/>
          </a:xfrm>
          <a:prstGeom prst="line">
            <a:avLst/>
          </a:prstGeom>
          <a:ln cap="sq" w="15840">
            <a:solidFill>
              <a:srgbClr val="ffff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569880" y="2268360"/>
            <a:ext cx="397080" cy="7956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98280" y="2224080"/>
            <a:ext cx="453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488880" y="2028960"/>
            <a:ext cx="317520" cy="7920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55520" y="2077920"/>
            <a:ext cx="308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531720" y="1911240"/>
            <a:ext cx="155520" cy="3672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10880" y="1914480"/>
            <a:ext cx="4136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506520" y="1835280"/>
            <a:ext cx="139680" cy="2520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54080" y="1820880"/>
            <a:ext cx="3254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41360" y="1744560"/>
            <a:ext cx="169920" cy="2088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84600" y="1706400"/>
            <a:ext cx="3358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22360" y="1633680"/>
            <a:ext cx="88920" cy="13176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rot="2314200">
            <a:off x="241560" y="149076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11280" y="1765440"/>
            <a:ext cx="34920" cy="6984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46200" y="1835280"/>
            <a:ext cx="41040" cy="7596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87240" y="1911240"/>
            <a:ext cx="119160" cy="11772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806400" y="2028960"/>
            <a:ext cx="160560" cy="31896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966960" y="2347920"/>
            <a:ext cx="198360" cy="247680"/>
          </a:xfrm>
          <a:prstGeom prst="line">
            <a:avLst/>
          </a:prstGeom>
          <a:ln cap="sq" w="15840">
            <a:solidFill>
              <a:srgbClr val="d600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165320" y="2595600"/>
            <a:ext cx="212760" cy="3960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V="1">
            <a:off x="1378080" y="2309760"/>
            <a:ext cx="253800" cy="3254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863640" y="1727280"/>
            <a:ext cx="403200" cy="32220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rot="2476800">
            <a:off x="580320" y="157968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915840" y="1658880"/>
            <a:ext cx="351000" cy="39060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rot="2399400">
            <a:off x="527400" y="147636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266840" y="2049480"/>
            <a:ext cx="365040" cy="260280"/>
          </a:xfrm>
          <a:prstGeom prst="line">
            <a:avLst/>
          </a:prstGeom>
          <a:ln cap="sq" w="1584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 flipV="1">
            <a:off x="1631880" y="2193840"/>
            <a:ext cx="488880" cy="11592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714240" y="1278000"/>
            <a:ext cx="471600" cy="10476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45240" y="1231920"/>
            <a:ext cx="354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85960" y="1074600"/>
            <a:ext cx="299880" cy="30816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95280" y="1025640"/>
            <a:ext cx="474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1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185840" y="1382760"/>
            <a:ext cx="304920" cy="13176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062000" y="830160"/>
            <a:ext cx="300240" cy="23508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62600" y="781200"/>
            <a:ext cx="573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243080" y="585720"/>
            <a:ext cx="179280" cy="32220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 rot="3763800">
            <a:off x="813600" y="261720"/>
            <a:ext cx="573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 flipH="1">
            <a:off x="1422000" y="628560"/>
            <a:ext cx="95400" cy="27936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 rot="6105600">
            <a:off x="1292400" y="287280"/>
            <a:ext cx="570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14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 flipH="1">
            <a:off x="1361880" y="907920"/>
            <a:ext cx="60120" cy="15732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362240" y="1065240"/>
            <a:ext cx="128520" cy="44928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490760" y="1514520"/>
            <a:ext cx="371520" cy="29988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820880" y="790560"/>
            <a:ext cx="39600" cy="45864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rot="5060400">
            <a:off x="1398240" y="34200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Lamprey TLR14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flipH="1">
            <a:off x="1860120" y="843120"/>
            <a:ext cx="136440" cy="40608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4725600">
            <a:off x="1531440" y="394200"/>
            <a:ext cx="784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Lamprey TLR14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860480" y="1249200"/>
            <a:ext cx="1800" cy="56520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862280" y="1814400"/>
            <a:ext cx="258480" cy="379440"/>
          </a:xfrm>
          <a:prstGeom prst="line">
            <a:avLst/>
          </a:prstGeom>
          <a:ln cap="sq" w="1584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120760" y="2193840"/>
            <a:ext cx="289080" cy="2588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2409840" y="2392200"/>
            <a:ext cx="422280" cy="604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249640" y="861840"/>
            <a:ext cx="83880" cy="120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3154200">
            <a:off x="1880640" y="633960"/>
            <a:ext cx="44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322360" y="793800"/>
            <a:ext cx="11160" cy="1890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3409800">
            <a:off x="1970640" y="554760"/>
            <a:ext cx="44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2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333520" y="982800"/>
            <a:ext cx="200160" cy="3506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440080" y="727200"/>
            <a:ext cx="190440" cy="311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2929800">
            <a:off x="2051280" y="49356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2535120" y="649440"/>
            <a:ext cx="127080" cy="727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2107800">
            <a:off x="2253960" y="52236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570040" y="588960"/>
            <a:ext cx="19080" cy="144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2350800">
            <a:off x="2215440" y="43344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570040" y="552600"/>
            <a:ext cx="19080" cy="507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3553800">
            <a:off x="2223720" y="315000"/>
            <a:ext cx="4352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acaqu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589120" y="603360"/>
            <a:ext cx="73080" cy="1188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2662200" y="722160"/>
            <a:ext cx="60480" cy="32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652840" y="582480"/>
            <a:ext cx="64800" cy="115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rot="3716400">
            <a:off x="2392200" y="368640"/>
            <a:ext cx="343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ors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630520" y="412920"/>
            <a:ext cx="141120" cy="2253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rot="16087200">
            <a:off x="2484000" y="226440"/>
            <a:ext cx="2703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Ba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2771640" y="403200"/>
            <a:ext cx="27000" cy="1587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15511200">
            <a:off x="2602080" y="22032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901960" y="378000"/>
            <a:ext cx="12600" cy="21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 rot="16208400">
            <a:off x="2727720" y="15804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 flipH="1">
            <a:off x="2914560" y="361800"/>
            <a:ext cx="22320" cy="381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 rot="16240800">
            <a:off x="2792880" y="143640"/>
            <a:ext cx="31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a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 flipH="1">
            <a:off x="2798640" y="399960"/>
            <a:ext cx="115920" cy="1620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H="1">
            <a:off x="2771280" y="561960"/>
            <a:ext cx="27000" cy="763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 flipH="1">
            <a:off x="2717640" y="638280"/>
            <a:ext cx="54000" cy="601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320" bIns="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717640" y="698400"/>
            <a:ext cx="5040" cy="558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722680" y="754200"/>
            <a:ext cx="64800" cy="810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 flipH="1">
            <a:off x="2857680" y="525600"/>
            <a:ext cx="110880" cy="2188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 rot="16833000">
            <a:off x="2827800" y="29628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bbi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079800" y="485640"/>
            <a:ext cx="7920" cy="142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 rot="17075400">
            <a:off x="2918160" y="239400"/>
            <a:ext cx="415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amster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 flipH="1">
            <a:off x="3154320" y="450720"/>
            <a:ext cx="6480" cy="1317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rot="17452800">
            <a:off x="3062520" y="21312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H="1">
            <a:off x="3153960" y="520560"/>
            <a:ext cx="57240" cy="61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 rot="18705000">
            <a:off x="3184200" y="36972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H="1">
            <a:off x="3087360" y="582480"/>
            <a:ext cx="66600" cy="460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H="1">
            <a:off x="2857320" y="628560"/>
            <a:ext cx="230040" cy="115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H="1">
            <a:off x="2787120" y="744480"/>
            <a:ext cx="70200" cy="907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H="1">
            <a:off x="2630520" y="835200"/>
            <a:ext cx="156960" cy="203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H="1">
            <a:off x="2533320" y="1038240"/>
            <a:ext cx="96840" cy="2952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533680" y="1333440"/>
            <a:ext cx="162000" cy="2286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 flipH="1">
            <a:off x="2914560" y="1052640"/>
            <a:ext cx="106560" cy="1522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 rot="18364800">
            <a:off x="2913840" y="76140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 flipH="1">
            <a:off x="2914200" y="1020600"/>
            <a:ext cx="198360" cy="1843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 rot="18457200">
            <a:off x="3015360" y="759960"/>
            <a:ext cx="5356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Arial"/>
              </a:rPr>
              <a:t>X. tropicalis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TLR2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 flipH="1">
            <a:off x="2695680" y="1204920"/>
            <a:ext cx="218880" cy="3571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695680" y="1562040"/>
            <a:ext cx="102960" cy="3492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 flipH="1">
            <a:off x="2965320" y="1112760"/>
            <a:ext cx="192240" cy="49068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 rot="18099000">
            <a:off x="3069720" y="871920"/>
            <a:ext cx="439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 flipH="1">
            <a:off x="3246120" y="933480"/>
            <a:ext cx="88920" cy="3380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 rot="17952000">
            <a:off x="3166920" y="574560"/>
            <a:ext cx="6955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Japanese flounder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 flipH="1">
            <a:off x="3246120" y="946080"/>
            <a:ext cx="206280" cy="32544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 rot="17761800">
            <a:off x="3362760" y="737640"/>
            <a:ext cx="319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Fugu TLR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 flipH="1">
            <a:off x="2964960" y="1271520"/>
            <a:ext cx="281160" cy="33192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 flipH="1">
            <a:off x="2798280" y="1603440"/>
            <a:ext cx="166680" cy="30780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798640" y="1911240"/>
            <a:ext cx="33480" cy="480960"/>
          </a:xfrm>
          <a:prstGeom prst="line">
            <a:avLst/>
          </a:prstGeom>
          <a:ln cap="sq" w="15840">
            <a:solidFill>
              <a:srgbClr val="009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832120" y="2392200"/>
            <a:ext cx="461880" cy="20664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 flipH="1">
            <a:off x="3471840" y="1243080"/>
            <a:ext cx="122400" cy="7477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rot="4676400">
            <a:off x="3396960" y="1018440"/>
            <a:ext cx="26604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ebrafis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3711600" y="1197000"/>
            <a:ext cx="17280" cy="5461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rot="4237200">
            <a:off x="3436560" y="948240"/>
            <a:ext cx="4032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cken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828960" y="1108080"/>
            <a:ext cx="147600" cy="4222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rot="3829200">
            <a:off x="3522960" y="862920"/>
            <a:ext cx="4183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latypus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3951360" y="984240"/>
            <a:ext cx="183960" cy="382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 rot="3301800">
            <a:off x="3601800" y="725040"/>
            <a:ext cx="4471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Opossum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4083120" y="766800"/>
            <a:ext cx="234720" cy="23796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rot="2418000">
            <a:off x="3754080" y="60120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bbi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4030560" y="528480"/>
            <a:ext cx="100080" cy="139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rot="3120600">
            <a:off x="3779640" y="349200"/>
            <a:ext cx="3009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ow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flipH="1">
            <a:off x="4130640" y="422280"/>
            <a:ext cx="14400" cy="2458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 rot="16534800">
            <a:off x="4035600" y="231480"/>
            <a:ext cx="266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4130640" y="668160"/>
            <a:ext cx="90360" cy="954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 flipH="1">
            <a:off x="4250880" y="492120"/>
            <a:ext cx="27000" cy="1825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 rot="16584600">
            <a:off x="4134960" y="269280"/>
            <a:ext cx="3438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orse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 flipH="1">
            <a:off x="4373640" y="488880"/>
            <a:ext cx="33120" cy="142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 rot="16837800">
            <a:off x="4293720" y="30708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a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 flipH="1">
            <a:off x="4373280" y="528480"/>
            <a:ext cx="189000" cy="1033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 rot="16582200">
            <a:off x="4442760" y="335160"/>
            <a:ext cx="2901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Dog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 flipH="1">
            <a:off x="4251240" y="631800"/>
            <a:ext cx="122400" cy="428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 flipH="1">
            <a:off x="4221000" y="674640"/>
            <a:ext cx="30240" cy="88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4221000" y="763560"/>
            <a:ext cx="68400" cy="1015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4464000" y="744480"/>
            <a:ext cx="1800" cy="1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 rot="19746000">
            <a:off x="4447080" y="528480"/>
            <a:ext cx="53856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Pigmy chimp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 flipH="1">
            <a:off x="4464000" y="741240"/>
            <a:ext cx="14400" cy="32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 rot="20071200">
            <a:off x="4500000" y="63972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himp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 flipH="1">
            <a:off x="4462560" y="744480"/>
            <a:ext cx="1440" cy="64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464000" y="749160"/>
            <a:ext cx="1800" cy="1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 rot="19114200">
            <a:off x="4392360" y="521640"/>
            <a:ext cx="3787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uman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 flipH="1">
            <a:off x="4464000" y="749160"/>
            <a:ext cx="14400" cy="1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 rot="20234400">
            <a:off x="4520880" y="693720"/>
            <a:ext cx="3574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Gorilla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 flipH="1">
            <a:off x="4462560" y="749160"/>
            <a:ext cx="1440" cy="1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 flipH="1">
            <a:off x="4289040" y="750960"/>
            <a:ext cx="173160" cy="1141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292640" y="878040"/>
            <a:ext cx="31680" cy="1332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317840" y="1004760"/>
            <a:ext cx="60480" cy="1414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 flipH="1">
            <a:off x="4549320" y="863640"/>
            <a:ext cx="88920" cy="1540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 rot="19978200">
            <a:off x="4610160" y="695160"/>
            <a:ext cx="41508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Hamster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 flipH="1">
            <a:off x="4721040" y="819000"/>
            <a:ext cx="60120" cy="1429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 rot="20495400">
            <a:off x="4783320" y="712440"/>
            <a:ext cx="3650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Mouse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 flipH="1">
            <a:off x="4721400" y="888840"/>
            <a:ext cx="126720" cy="730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 rot="20286600">
            <a:off x="4851000" y="788760"/>
            <a:ext cx="27360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Rat TLR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 flipH="1">
            <a:off x="4549320" y="961920"/>
            <a:ext cx="171720" cy="5580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 flipH="1">
            <a:off x="4378320" y="1017720"/>
            <a:ext cx="171360" cy="12852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 flipH="1">
            <a:off x="4134960" y="1146240"/>
            <a:ext cx="243000" cy="220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 flipH="1">
            <a:off x="3976200" y="1366920"/>
            <a:ext cx="158760" cy="1634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 flipH="1">
            <a:off x="3728880" y="1530360"/>
            <a:ext cx="247680" cy="21276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 flipH="1">
            <a:off x="3471840" y="1743120"/>
            <a:ext cx="257040" cy="24768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 flipH="1">
            <a:off x="3294000" y="1990800"/>
            <a:ext cx="177840" cy="608040"/>
          </a:xfrm>
          <a:prstGeom prst="line">
            <a:avLst/>
          </a:prstGeom>
          <a:ln cap="sq" w="1584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294000" y="2598840"/>
            <a:ext cx="293760" cy="366480"/>
          </a:xfrm>
          <a:prstGeom prst="line">
            <a:avLst/>
          </a:prstGeom>
          <a:ln cap="sq"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45760" y="3040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28120" y="3213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729720" y="3041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898200" y="28274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77440" y="26384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456840" y="29304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23360" y="2816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590040" y="28764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713880" y="2789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1009440" y="28494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1248840" y="28400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388880" y="2619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717120" y="2389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158480" y="2511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977400" y="22906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812520" y="19861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698040" y="1855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657000" y="1784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618840" y="16923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1261800" y="1978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1626840" y="23050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2126880" y="21258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1742760" y="12272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1252080" y="10652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1109160" y="13809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1382400" y="15080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779120" y="1806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217240" y="963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2504880" y="10018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2776320" y="835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3114360" y="5983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3022200" y="663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2860200" y="7412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792160" y="1160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3261960" y="12510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900160" y="1539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677680" y="19065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577600" y="15397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2450880" y="13240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2655360" y="7650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590560" y="7192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2545920" y="5954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2787120" y="3603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2809440" y="5349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2785680" y="6015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2736360" y="67320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4681080" y="9651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4506480" y="103176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4114440" y="13795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3947760" y="154296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3690720" y="176220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3477960" y="197964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838240" y="22939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2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3309480" y="25480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4408200" y="7732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4200120" y="98748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4044600" y="63648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4144680" y="74772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4176360" y="6332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5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4296960" y="566640"/>
            <a:ext cx="7092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4341600" y="1163520"/>
            <a:ext cx="105840" cy="7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8T11:25:08Z</dcterms:created>
  <dc:creator>Nicholas David Temperley</dc:creator>
  <dc:description/>
  <dc:language>en-US</dc:language>
  <cp:lastModifiedBy>Nicholas David Temperley</cp:lastModifiedBy>
  <dcterms:modified xsi:type="dcterms:W3CDTF">2008-01-31T15:40:32Z</dcterms:modified>
  <cp:revision>31</cp:revision>
  <dc:subject/>
  <dc:title>Slide 1</dc:title>
</cp:coreProperties>
</file>